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64" r:id="rId2"/>
    <p:sldId id="265" r:id="rId3"/>
    <p:sldId id="266" r:id="rId4"/>
    <p:sldId id="273" r:id="rId5"/>
    <p:sldId id="268" r:id="rId6"/>
    <p:sldId id="269" r:id="rId7"/>
    <p:sldId id="271" r:id="rId8"/>
    <p:sldId id="272" r:id="rId9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7016" autoAdjust="0"/>
    <p:restoredTop sz="95429" autoAdjust="0"/>
  </p:normalViewPr>
  <p:slideViewPr>
    <p:cSldViewPr snapToGrid="0">
      <p:cViewPr>
        <p:scale>
          <a:sx n="120" d="100"/>
          <a:sy n="120" d="100"/>
        </p:scale>
        <p:origin x="-3108" y="143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C89347-D995-45EE-B4EA-4211E827F75D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A02608-172C-4447-9126-99B091C496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9506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5A02608-172C-4447-9126-99B091C496D9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962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3812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7794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1410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741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6772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1830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2341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41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7723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9533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998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0820D-F28F-44E4-96FF-8EFDDA509F61}" type="datetimeFigureOut">
              <a:rPr lang="en-GB" smtClean="0"/>
              <a:t>21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A0626A-CDF8-40BF-8368-A15EFC86E3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4703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65" b="1440"/>
          <a:stretch/>
        </p:blipFill>
        <p:spPr bwMode="auto">
          <a:xfrm>
            <a:off x="128449" y="1508760"/>
            <a:ext cx="6532523" cy="56826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04632" y="7338266"/>
            <a:ext cx="51010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able 1 : FLT-PET Data: Boundaries determined by test re-test data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89147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821" y="805100"/>
            <a:ext cx="5159829" cy="4146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140279" y="5182909"/>
            <a:ext cx="45496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gure 1 Ki67 Scatter plot for samples, scorer 1 vs scorer 2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89845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1600190"/>
              </p:ext>
            </p:extLst>
          </p:nvPr>
        </p:nvGraphicFramePr>
        <p:xfrm>
          <a:off x="867702" y="1249300"/>
          <a:ext cx="4978400" cy="346964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995680"/>
                <a:gridCol w="995680"/>
                <a:gridCol w="995680"/>
                <a:gridCol w="995680"/>
                <a:gridCol w="995680"/>
              </a:tblGrid>
              <a:tr h="370840">
                <a:tc>
                  <a:txBody>
                    <a:bodyPr/>
                    <a:lstStyle/>
                    <a:p>
                      <a:r>
                        <a:rPr lang="en-GB" dirty="0" smtClean="0"/>
                        <a:t>Patient</a:t>
                      </a:r>
                      <a:r>
                        <a:rPr lang="en-GB" baseline="0" dirty="0" smtClean="0"/>
                        <a:t> ID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Pre-Ki67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Post-Ki67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Diff Ki67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baseline="0" dirty="0" smtClean="0"/>
                        <a:t>Percentage</a:t>
                      </a:r>
                    </a:p>
                    <a:p>
                      <a:r>
                        <a:rPr lang="en-GB" baseline="0" dirty="0" smtClean="0"/>
                        <a:t>Difference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b="1" dirty="0" smtClean="0"/>
                        <a:t>14</a:t>
                      </a:r>
                      <a:endParaRPr lang="en-GB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19.5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4.6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14.9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76.4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b="1" dirty="0" smtClean="0"/>
                        <a:t>12</a:t>
                      </a:r>
                      <a:endParaRPr lang="en-GB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12.7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15.2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-2.5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-19.7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b="1" dirty="0" smtClean="0"/>
                        <a:t>11</a:t>
                      </a:r>
                      <a:endParaRPr lang="en-GB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36.6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26.3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6.3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19.3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b="1" dirty="0" smtClean="0"/>
                        <a:t>9</a:t>
                      </a:r>
                      <a:endParaRPr lang="en-GB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34.2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16.3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17.9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52.3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b="1" dirty="0" smtClean="0"/>
                        <a:t>7</a:t>
                      </a:r>
                      <a:endParaRPr lang="en-GB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27.7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6.7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21.0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>
                          <a:solidFill>
                            <a:schemeClr val="tx1"/>
                          </a:solidFill>
                        </a:rPr>
                        <a:t>75.8</a:t>
                      </a:r>
                      <a:endParaRPr lang="en-GB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b="1" dirty="0" smtClean="0"/>
                        <a:t>5</a:t>
                      </a:r>
                      <a:endParaRPr lang="en-GB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54.5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43.0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11.5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21.1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b="1" dirty="0" smtClean="0"/>
                        <a:t>2</a:t>
                      </a:r>
                      <a:endParaRPr lang="en-GB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39.3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12.3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27.0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68.7</a:t>
                      </a:r>
                      <a:endParaRPr lang="en-GB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Median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mtClean="0"/>
                        <a:t>14.90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dirty="0" smtClean="0"/>
                        <a:t>52.3%</a:t>
                      </a:r>
                      <a:endParaRPr lang="en-GB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83104" y="5015849"/>
            <a:ext cx="5272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able 2: Ki67 scores and differences pre-and post-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rosustat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reatment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4134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8453387"/>
              </p:ext>
            </p:extLst>
          </p:nvPr>
        </p:nvGraphicFramePr>
        <p:xfrm>
          <a:off x="856299" y="1095280"/>
          <a:ext cx="4688203" cy="6624828"/>
        </p:xfrm>
        <a:graphic>
          <a:graphicData uri="http://schemas.openxmlformats.org/drawingml/2006/table">
            <a:tbl>
              <a:tblPr firstRow="1" firstCol="1" bandRow="1"/>
              <a:tblGrid>
                <a:gridCol w="1076221"/>
                <a:gridCol w="1152668"/>
                <a:gridCol w="999232"/>
                <a:gridCol w="1460082"/>
              </a:tblGrid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re P+IS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ost P+IS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Difference (Post-Pre)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STS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2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1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7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2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9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1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2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4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1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EST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2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1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5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1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7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1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9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1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2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4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AROM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2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5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5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5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7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3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9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1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6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2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2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4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6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3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7BHSD1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2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1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5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7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9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1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2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4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17BHSD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2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5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7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9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1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6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2 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5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3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0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629">
                <a:tc>
                  <a:txBody>
                    <a:bodyPr/>
                    <a:lstStyle/>
                    <a:p>
                      <a:pPr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Patient 14 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4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2</a:t>
                      </a:r>
                      <a:endParaRPr lang="en-GB" sz="9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Calibri"/>
                          <a:cs typeface="Times New Roman"/>
                        </a:rPr>
                        <a:t>-2</a:t>
                      </a:r>
                      <a:endParaRPr lang="en-GB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8555" marR="5855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31798" y="7962900"/>
            <a:ext cx="614302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able 3 Summary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of changes in expression of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ntratumoral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teroidogenic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nzymes</a:t>
            </a:r>
          </a:p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pre-and post-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rosustat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treatment</a:t>
            </a:r>
          </a:p>
        </p:txBody>
      </p:sp>
    </p:spTree>
    <p:extLst>
      <p:ext uri="{BB962C8B-B14F-4D97-AF65-F5344CB8AC3E}">
        <p14:creationId xmlns:p14="http://schemas.microsoft.com/office/powerpoint/2010/main" val="35678788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6325" y="652463"/>
            <a:ext cx="4662701" cy="3738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245" b="6716"/>
          <a:stretch/>
        </p:blipFill>
        <p:spPr bwMode="auto">
          <a:xfrm>
            <a:off x="1114638" y="4981575"/>
            <a:ext cx="4557713" cy="35123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707508" y="587108"/>
            <a:ext cx="396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A)</a:t>
            </a:r>
            <a:endParaRPr lang="en-GB" sz="12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875776" y="4843075"/>
            <a:ext cx="396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B)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8719485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2" r="6028"/>
          <a:stretch/>
        </p:blipFill>
        <p:spPr bwMode="auto">
          <a:xfrm>
            <a:off x="514351" y="957263"/>
            <a:ext cx="5416284" cy="4433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740"/>
          <a:stretch/>
        </p:blipFill>
        <p:spPr bwMode="auto">
          <a:xfrm>
            <a:off x="304801" y="5534025"/>
            <a:ext cx="5508478" cy="4243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311268" y="935545"/>
            <a:ext cx="396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)</a:t>
            </a:r>
            <a:endParaRPr lang="en-GB" sz="12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374133" y="5424100"/>
            <a:ext cx="396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D)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23832739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8" r="16699"/>
          <a:stretch/>
        </p:blipFill>
        <p:spPr bwMode="auto">
          <a:xfrm>
            <a:off x="469356" y="437966"/>
            <a:ext cx="5429249" cy="43864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87" t="11972" r="11273"/>
          <a:stretch/>
        </p:blipFill>
        <p:spPr bwMode="auto">
          <a:xfrm>
            <a:off x="364580" y="5338577"/>
            <a:ext cx="5915025" cy="42837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348188" y="372611"/>
            <a:ext cx="396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E)</a:t>
            </a:r>
            <a:endParaRPr lang="en-GB" sz="12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348188" y="5077960"/>
            <a:ext cx="396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F)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4621383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72" r="10865"/>
          <a:stretch/>
        </p:blipFill>
        <p:spPr bwMode="auto">
          <a:xfrm>
            <a:off x="619125" y="611706"/>
            <a:ext cx="5478050" cy="46053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459834" y="742443"/>
            <a:ext cx="396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G)</a:t>
            </a:r>
            <a:endParaRPr lang="en-GB" sz="1200" b="1" dirty="0"/>
          </a:p>
        </p:txBody>
      </p:sp>
      <p:sp>
        <p:nvSpPr>
          <p:cNvPr id="2" name="TextBox 1"/>
          <p:cNvSpPr txBox="1"/>
          <p:nvPr/>
        </p:nvSpPr>
        <p:spPr>
          <a:xfrm>
            <a:off x="453155" y="5217042"/>
            <a:ext cx="637562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2 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Graphs showing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fferences from baseline in A) 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estradiol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B) Oestrone, </a:t>
            </a:r>
          </a:p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rostenedione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D) Oestrone Sulphate,  E) 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hydroepiandrosterone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hate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</a:p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) Oestrone Sulphate: Oestrone ratio; G) DHEA:DHEAS Ratio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0637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5</TotalTime>
  <Words>368</Words>
  <Application>Microsoft Office PowerPoint</Application>
  <PresentationFormat>A4 Paper (210x297 mm)</PresentationFormat>
  <Paragraphs>244</Paragraphs>
  <Slides>8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mperial College Lond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ny, Laura M</dc:creator>
  <cp:lastModifiedBy>Palmieri, Carlo</cp:lastModifiedBy>
  <cp:revision>35</cp:revision>
  <cp:lastPrinted>2017-01-16T13:44:04Z</cp:lastPrinted>
  <dcterms:created xsi:type="dcterms:W3CDTF">2016-03-11T16:32:15Z</dcterms:created>
  <dcterms:modified xsi:type="dcterms:W3CDTF">2017-07-21T10:04:14Z</dcterms:modified>
</cp:coreProperties>
</file>